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5247F64-37B1-A156-C963-F84EF9C2569E}" name=" " initials=" " userId=" " providerId="None"/>
  <p188:author id="{AE0ADE67-9BF4-E160-3418-A5AD2D05E355}" name="Brian Law (HI)" initials="BL(" userId="S::Brian.Law@healthinteractions.com::5d8d0222-c33e-440b-86e7-a9146e8c8d2a" providerId="AD"/>
  <p188:author id="{4F7B25A4-081E-5C86-60D8-E37FC1357A09}" name="David Morgan (HI)" initials="DM(" userId="S::David.Morgan@healthinteractions.com::6e806c02-628e-4819-a005-96c2e6ccd384" providerId="AD"/>
  <p188:author id="{4B10AFB4-83B9-C3F2-33C7-AA3718D71BAD}" name="Eleanor Porteous (HI)" initials="EP(" userId="S::Eleanor.Porteous@healthinteractions.com::28ec61c9-af44-46b9-a8bd-919c12120866" providerId="AD"/>
  <p188:author id="{3D7D2EDE-2CAA-AFFF-F152-E81C7F609843}" name="Health Interactions" initials="HI" userId="Health Interactions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437A"/>
    <a:srgbClr val="005DA5"/>
    <a:srgbClr val="00385E"/>
    <a:srgbClr val="004277"/>
    <a:srgbClr val="296DC0"/>
    <a:srgbClr val="0092F7"/>
    <a:srgbClr val="0066B5"/>
    <a:srgbClr val="00447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61" autoAdjust="0"/>
    <p:restoredTop sz="92676" autoAdjust="0"/>
  </p:normalViewPr>
  <p:slideViewPr>
    <p:cSldViewPr snapToGrid="0">
      <p:cViewPr varScale="1">
        <p:scale>
          <a:sx n="80" d="100"/>
          <a:sy n="80" d="100"/>
        </p:scale>
        <p:origin x="101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0/04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4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46931" y="-42379"/>
            <a:ext cx="10138656" cy="1163395"/>
          </a:xfrm>
          <a:prstGeom prst="rect">
            <a:avLst/>
          </a:prstGeom>
          <a:noFill/>
        </p:spPr>
        <p:txBody>
          <a:bodyPr vert="horz" wrap="square" lIns="0" tIns="0" rIns="0" bIns="0" rtlCol="0" anchor="ctr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Real-world evidence on the dosing and safety of C.E.R.A. in pediatric dialysis patients: findings from the International Pediatric Dialysis Network  registrie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7307" y="1167181"/>
            <a:ext cx="12154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Real-world evidence supports C.E.R.A. for management of anemia in patients on long-term dialysis.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44967" y="1758951"/>
            <a:ext cx="11505934" cy="400110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r>
              <a:rPr lang="en-GB" sz="2000" b="1" dirty="0">
                <a:solidFill>
                  <a:srgbClr val="0065AA"/>
                </a:solidFill>
              </a:rPr>
              <a:t>DESIGN &amp; OUTCOMES</a:t>
            </a:r>
            <a:r>
              <a:rPr lang="en-GB" sz="2000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ohlhas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81484" y="5765334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Real-world evidence suggests that C.E.R.A. may allow for successful management of anemia in children on long-term dialysis. </a:t>
            </a:r>
            <a:br>
              <a:rPr lang="en-GB" dirty="0">
                <a:solidFill>
                  <a:schemeClr val="bg1"/>
                </a:solidFill>
              </a:rPr>
            </a:br>
            <a:r>
              <a:rPr lang="en-GB" dirty="0">
                <a:solidFill>
                  <a:schemeClr val="bg1"/>
                </a:solidFill>
              </a:rPr>
              <a:t>C.E.R.A. appears to have a favorable safety profile in this population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A3ED5DC-BA19-1B63-20F6-D2C275A0768F}"/>
              </a:ext>
            </a:extLst>
          </p:cNvPr>
          <p:cNvGrpSpPr/>
          <p:nvPr/>
        </p:nvGrpSpPr>
        <p:grpSpPr>
          <a:xfrm>
            <a:off x="2136257" y="2771540"/>
            <a:ext cx="810000" cy="1505113"/>
            <a:chOff x="1346621" y="3372446"/>
            <a:chExt cx="810000" cy="1505113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97B78BE-3705-6EC8-5101-24A13406B801}"/>
                </a:ext>
              </a:extLst>
            </p:cNvPr>
            <p:cNvSpPr/>
            <p:nvPr/>
          </p:nvSpPr>
          <p:spPr>
            <a:xfrm>
              <a:off x="1346621" y="3372446"/>
              <a:ext cx="810000" cy="543577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2000" dirty="0"/>
                <a:t>IPPN</a:t>
              </a:r>
            </a:p>
            <a:p>
              <a:pPr algn="ctr"/>
              <a:r>
                <a:rPr lang="en-GB" sz="2000" dirty="0"/>
                <a:t>N = 177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7662F8CB-EDB0-3B0D-61C6-B12D0F7B67C9}"/>
                </a:ext>
              </a:extLst>
            </p:cNvPr>
            <p:cNvSpPr/>
            <p:nvPr/>
          </p:nvSpPr>
          <p:spPr>
            <a:xfrm>
              <a:off x="1346621" y="4333982"/>
              <a:ext cx="810000" cy="543577"/>
            </a:xfrm>
            <a:prstGeom prst="rect">
              <a:avLst/>
            </a:prstGeom>
            <a:solidFill>
              <a:srgbClr val="AA0065"/>
            </a:solidFill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2000" dirty="0">
                  <a:solidFill>
                    <a:schemeClr val="bg1"/>
                  </a:solidFill>
                </a:rPr>
                <a:t>IPHN</a:t>
              </a:r>
            </a:p>
            <a:p>
              <a:pPr algn="ctr"/>
              <a:r>
                <a:rPr lang="en-GB" sz="2000" dirty="0">
                  <a:solidFill>
                    <a:schemeClr val="bg1"/>
                  </a:solidFill>
                </a:rPr>
                <a:t>N = 52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FD66F51-7A2F-0547-A72C-CFDA95EAD181}"/>
              </a:ext>
            </a:extLst>
          </p:cNvPr>
          <p:cNvGrpSpPr/>
          <p:nvPr/>
        </p:nvGrpSpPr>
        <p:grpSpPr>
          <a:xfrm>
            <a:off x="3952407" y="1822534"/>
            <a:ext cx="2969611" cy="1800000"/>
            <a:chOff x="3794193" y="1748589"/>
            <a:chExt cx="2348095" cy="1783255"/>
          </a:xfrm>
        </p:grpSpPr>
        <p:pic>
          <p:nvPicPr>
            <p:cNvPr id="14" name="Picture 13" descr="Chart, line chart&#10;&#10;Description automatically generated">
              <a:extLst>
                <a:ext uri="{FF2B5EF4-FFF2-40B4-BE49-F238E27FC236}">
                  <a16:creationId xmlns:a16="http://schemas.microsoft.com/office/drawing/2014/main" id="{6825CAE8-98F7-0797-1F63-6010CEEB3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51971" b="28854"/>
            <a:stretch/>
          </p:blipFill>
          <p:spPr>
            <a:xfrm>
              <a:off x="3980388" y="1813696"/>
              <a:ext cx="2041815" cy="1674122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8D3AF5B-27BD-BD41-8174-B8C722B2DF55}"/>
                </a:ext>
              </a:extLst>
            </p:cNvPr>
            <p:cNvSpPr/>
            <p:nvPr/>
          </p:nvSpPr>
          <p:spPr>
            <a:xfrm>
              <a:off x="3794193" y="1748589"/>
              <a:ext cx="2348095" cy="1783255"/>
            </a:xfrm>
            <a:prstGeom prst="rect">
              <a:avLst/>
            </a:prstGeom>
            <a:noFill/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65AA00"/>
                </a:solidFill>
              </a:endParaRP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44A4334A-D5EF-BD90-94FF-538092330EDF}"/>
              </a:ext>
            </a:extLst>
          </p:cNvPr>
          <p:cNvGrpSpPr/>
          <p:nvPr/>
        </p:nvGrpSpPr>
        <p:grpSpPr>
          <a:xfrm>
            <a:off x="3952407" y="3734288"/>
            <a:ext cx="3011417" cy="1800000"/>
            <a:chOff x="3794193" y="3953856"/>
            <a:chExt cx="2381151" cy="2087759"/>
          </a:xfrm>
        </p:grpSpPr>
        <p:pic>
          <p:nvPicPr>
            <p:cNvPr id="21" name="Picture 20" descr="Chart, line chart&#10;&#10;Description automatically generated">
              <a:extLst>
                <a:ext uri="{FF2B5EF4-FFF2-40B4-BE49-F238E27FC236}">
                  <a16:creationId xmlns:a16="http://schemas.microsoft.com/office/drawing/2014/main" id="{0FB33D82-1694-F009-66BC-0C88671602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b="28503"/>
            <a:stretch/>
          </p:blipFill>
          <p:spPr>
            <a:xfrm>
              <a:off x="3827249" y="4018713"/>
              <a:ext cx="2348095" cy="1967998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D9DCE460-0811-ABAF-D125-E6973BF0B134}"/>
                </a:ext>
              </a:extLst>
            </p:cNvPr>
            <p:cNvSpPr/>
            <p:nvPr/>
          </p:nvSpPr>
          <p:spPr>
            <a:xfrm>
              <a:off x="3794193" y="3953856"/>
              <a:ext cx="2348095" cy="2087759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AA0065"/>
                </a:solidFill>
              </a:endParaRP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9B24C408-D3B4-6D80-2EBE-D5B2BB786448}"/>
              </a:ext>
            </a:extLst>
          </p:cNvPr>
          <p:cNvSpPr txBox="1"/>
          <p:nvPr/>
        </p:nvSpPr>
        <p:spPr>
          <a:xfrm>
            <a:off x="1150698" y="3303561"/>
            <a:ext cx="2749280" cy="400110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Long-term P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6234242-98CC-8783-2C25-E7C43E3F7B57}"/>
              </a:ext>
            </a:extLst>
          </p:cNvPr>
          <p:cNvSpPr txBox="1"/>
          <p:nvPr/>
        </p:nvSpPr>
        <p:spPr>
          <a:xfrm>
            <a:off x="1150698" y="4290521"/>
            <a:ext cx="2749280" cy="400110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Long-term HD</a:t>
            </a:r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2083436F-8033-4530-23C2-5DAC4031133F}"/>
              </a:ext>
            </a:extLst>
          </p:cNvPr>
          <p:cNvSpPr/>
          <p:nvPr/>
        </p:nvSpPr>
        <p:spPr>
          <a:xfrm>
            <a:off x="472130" y="26257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78C0C65A-2F18-9B6A-FB47-5F14B032701C}"/>
              </a:ext>
            </a:extLst>
          </p:cNvPr>
          <p:cNvSpPr/>
          <p:nvPr/>
        </p:nvSpPr>
        <p:spPr>
          <a:xfrm>
            <a:off x="637414" y="26762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80053B6-D84E-40B9-5555-7AA8226B3E9E}"/>
              </a:ext>
            </a:extLst>
          </p:cNvPr>
          <p:cNvSpPr txBox="1"/>
          <p:nvPr/>
        </p:nvSpPr>
        <p:spPr>
          <a:xfrm>
            <a:off x="-2907" y="3726118"/>
            <a:ext cx="1596262" cy="1015663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pPr algn="ctr"/>
            <a:r>
              <a:rPr lang="en-GB" sz="2000" dirty="0">
                <a:solidFill>
                  <a:srgbClr val="00385E"/>
                </a:solidFill>
              </a:rPr>
              <a:t>≥1 visit at </a:t>
            </a:r>
            <a:br>
              <a:rPr lang="en-GB" sz="2000" dirty="0">
                <a:solidFill>
                  <a:srgbClr val="00385E"/>
                </a:solidFill>
              </a:rPr>
            </a:br>
            <a:r>
              <a:rPr lang="en-GB" sz="2000" dirty="0">
                <a:solidFill>
                  <a:srgbClr val="00385E"/>
                </a:solidFill>
              </a:rPr>
              <a:t>&lt;18 years under C.E.R.A.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3BC56B8-F762-E66D-0640-3E813BCC0DB0}"/>
              </a:ext>
            </a:extLst>
          </p:cNvPr>
          <p:cNvSpPr txBox="1"/>
          <p:nvPr/>
        </p:nvSpPr>
        <p:spPr>
          <a:xfrm>
            <a:off x="7214939" y="1804203"/>
            <a:ext cx="4665600" cy="1015663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Hb concentrations: </a:t>
            </a:r>
            <a:r>
              <a:rPr lang="en-GB" sz="2000" dirty="0">
                <a:solidFill>
                  <a:srgbClr val="00437A"/>
                </a:solidFill>
              </a:rPr>
              <a:t>C.E.R.A. treatment was associated with maintenance of Hb levels within the target range (10–12 g/dL).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B6218B8-119F-0B8A-214C-666A3EB8CB68}"/>
              </a:ext>
            </a:extLst>
          </p:cNvPr>
          <p:cNvSpPr txBox="1"/>
          <p:nvPr/>
        </p:nvSpPr>
        <p:spPr>
          <a:xfrm>
            <a:off x="7214940" y="3012196"/>
            <a:ext cx="4977059" cy="1015663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C.E.R.A. dosing: </a:t>
            </a:r>
            <a:br>
              <a:rPr lang="en-GB" sz="2000" b="1" dirty="0">
                <a:solidFill>
                  <a:srgbClr val="00437A"/>
                </a:solidFill>
              </a:rPr>
            </a:br>
            <a:r>
              <a:rPr lang="en-GB" sz="2000" dirty="0">
                <a:solidFill>
                  <a:srgbClr val="00437A"/>
                </a:solidFill>
              </a:rPr>
              <a:t>Body weight-related doses decreased with </a:t>
            </a:r>
          </a:p>
          <a:p>
            <a:r>
              <a:rPr lang="en-GB" sz="2000" dirty="0">
                <a:solidFill>
                  <a:srgbClr val="00437A"/>
                </a:solidFill>
              </a:rPr>
              <a:t>age in both groups.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DB4F37-D124-6D7C-A153-34944FD43C49}"/>
              </a:ext>
            </a:extLst>
          </p:cNvPr>
          <p:cNvSpPr txBox="1"/>
          <p:nvPr/>
        </p:nvSpPr>
        <p:spPr>
          <a:xfrm>
            <a:off x="7214939" y="4220189"/>
            <a:ext cx="4664596" cy="1015663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Safety: </a:t>
            </a:r>
            <a:r>
              <a:rPr lang="en-GB" sz="2000" dirty="0">
                <a:solidFill>
                  <a:srgbClr val="00437A"/>
                </a:solidFill>
              </a:rPr>
              <a:t>Hospitalization rate and distribution of causes, as well as patient mortality, did not reveal any safety signals. 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C4D9A3A-4D65-61E5-E552-37AEB15CA5A6}"/>
              </a:ext>
            </a:extLst>
          </p:cNvPr>
          <p:cNvCxnSpPr/>
          <p:nvPr/>
        </p:nvCxnSpPr>
        <p:spPr>
          <a:xfrm>
            <a:off x="1228021" y="3693561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B502873B-445A-DED5-AB0F-9130BCA30BC0}"/>
              </a:ext>
            </a:extLst>
          </p:cNvPr>
          <p:cNvCxnSpPr/>
          <p:nvPr/>
        </p:nvCxnSpPr>
        <p:spPr>
          <a:xfrm>
            <a:off x="3076736" y="3675679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F1820254-30BD-59EF-1416-A0BC2EEEC1CF}"/>
              </a:ext>
            </a:extLst>
          </p:cNvPr>
          <p:cNvSpPr txBox="1"/>
          <p:nvPr/>
        </p:nvSpPr>
        <p:spPr>
          <a:xfrm>
            <a:off x="1660895" y="2270031"/>
            <a:ext cx="1806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b="1" dirty="0"/>
              <a:t>IPDN registries</a:t>
            </a:r>
            <a:endParaRPr lang="en-GB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74F5FFA-0EC0-05C7-32E8-117A9E68071E}"/>
              </a:ext>
            </a:extLst>
          </p:cNvPr>
          <p:cNvSpPr txBox="1"/>
          <p:nvPr/>
        </p:nvSpPr>
        <p:spPr>
          <a:xfrm>
            <a:off x="57769" y="4736866"/>
            <a:ext cx="3658945" cy="830997"/>
          </a:xfrm>
          <a:prstGeom prst="rect">
            <a:avLst/>
          </a:prstGeom>
          <a:noFill/>
        </p:spPr>
        <p:txBody>
          <a:bodyPr wrap="square" lIns="36000" rIns="36000" rtlCol="0">
            <a:spAutoFit/>
          </a:bodyPr>
          <a:lstStyle/>
          <a:p>
            <a:r>
              <a:rPr lang="en-GB" sz="1200" b="1" dirty="0">
                <a:solidFill>
                  <a:srgbClr val="00437A"/>
                </a:solidFill>
              </a:rPr>
              <a:t>Abbreviations: </a:t>
            </a:r>
            <a:r>
              <a:rPr lang="en-GB" sz="1200" dirty="0">
                <a:solidFill>
                  <a:srgbClr val="00437A"/>
                </a:solidFill>
              </a:rPr>
              <a:t>C.E.R.A., continuous erythropoietin receptor activator; Hb, hemoglobin; HD, hemodialysis; </a:t>
            </a:r>
            <a:br>
              <a:rPr lang="en-GB" sz="1200" dirty="0">
                <a:solidFill>
                  <a:srgbClr val="00437A"/>
                </a:solidFill>
              </a:rPr>
            </a:br>
            <a:r>
              <a:rPr lang="en-GB" sz="1200" dirty="0">
                <a:solidFill>
                  <a:srgbClr val="00437A"/>
                </a:solidFill>
              </a:rPr>
              <a:t>PD, peritoneal dialysis. IPDN, International Pediatric Dialysis Network</a:t>
            </a:r>
          </a:p>
        </p:txBody>
      </p:sp>
    </p:spTree>
    <p:extLst>
      <p:ext uri="{BB962C8B-B14F-4D97-AF65-F5344CB8AC3E}">
        <p14:creationId xmlns:p14="http://schemas.microsoft.com/office/powerpoint/2010/main" val="340415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Words>246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8</cp:revision>
  <dcterms:created xsi:type="dcterms:W3CDTF">2019-06-13T12:30:18Z</dcterms:created>
  <dcterms:modified xsi:type="dcterms:W3CDTF">2023-04-10T22:40:38Z</dcterms:modified>
</cp:coreProperties>
</file>